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65" autoAdjust="0"/>
  </p:normalViewPr>
  <p:slideViewPr>
    <p:cSldViewPr showGuides="1">
      <p:cViewPr>
        <p:scale>
          <a:sx n="66" d="100"/>
          <a:sy n="66" d="100"/>
        </p:scale>
        <p:origin x="-1896" y="-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ujiuser1\Documents\PTX3&#38306;&#36899;\Pros%20one\PTX3%20knock%20down%20efficacy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icacy of PTX3 knock down</a:t>
            </a:r>
            <a:r>
              <a:rPr lang="en-US" altLang="en-US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P-1 macrophage</a:t>
            </a:r>
            <a:endParaRPr lang="en-US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4233333333333335"/>
          <c:y val="0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H$3</c:f>
              <c:strCache>
                <c:ptCount val="1"/>
                <c:pt idx="0">
                  <c:v>PTX3 concentration ng/m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I$4:$I$7</c:f>
                <c:numCache>
                  <c:formatCode>General</c:formatCode>
                  <c:ptCount val="4"/>
                  <c:pt idx="0">
                    <c:v>4.4749999999999991E-2</c:v>
                  </c:pt>
                  <c:pt idx="1">
                    <c:v>4.9999999999999992E-3</c:v>
                  </c:pt>
                  <c:pt idx="2">
                    <c:v>4.4475000000000042</c:v>
                  </c:pt>
                  <c:pt idx="3">
                    <c:v>0.100000000000000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G$4:$G$7</c:f>
              <c:strCache>
                <c:ptCount val="4"/>
                <c:pt idx="0">
                  <c:v>control siRNA</c:v>
                </c:pt>
                <c:pt idx="1">
                  <c:v>PTX3 siRNA</c:v>
                </c:pt>
                <c:pt idx="2">
                  <c:v>control siRNA+LPS</c:v>
                </c:pt>
                <c:pt idx="3">
                  <c:v>PTX3 siRNA+LPS</c:v>
                </c:pt>
              </c:strCache>
            </c:strRef>
          </c:cat>
          <c:val>
            <c:numRef>
              <c:f>Sheet1!$H$4:$H$7</c:f>
              <c:numCache>
                <c:formatCode>General</c:formatCode>
                <c:ptCount val="4"/>
                <c:pt idx="0">
                  <c:v>0.23275000000000001</c:v>
                </c:pt>
                <c:pt idx="1">
                  <c:v>3.4000000000000002E-2</c:v>
                </c:pt>
                <c:pt idx="2">
                  <c:v>18.267499999999998</c:v>
                </c:pt>
                <c:pt idx="3">
                  <c:v>2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5148800"/>
        <c:axId val="275150336"/>
      </c:barChart>
      <c:catAx>
        <c:axId val="275148800"/>
        <c:scaling>
          <c:orientation val="minMax"/>
        </c:scaling>
        <c:delete val="0"/>
        <c:axPos val="b"/>
        <c:majorTickMark val="out"/>
        <c:minorTickMark val="none"/>
        <c:tickLblPos val="nextTo"/>
        <c:crossAx val="275150336"/>
        <c:crosses val="autoZero"/>
        <c:auto val="1"/>
        <c:lblAlgn val="ctr"/>
        <c:lblOffset val="100"/>
        <c:noMultiLvlLbl val="0"/>
      </c:catAx>
      <c:valAx>
        <c:axId val="275150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751488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302636937487273"/>
          <c:y val="0.128791061844408"/>
          <c:w val="0.77901507952668614"/>
          <c:h val="0.580605619960322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12:$F$12</c:f>
                <c:numCache>
                  <c:formatCode>General</c:formatCode>
                  <c:ptCount val="2"/>
                  <c:pt idx="0">
                    <c:v>1.4185181528623383</c:v>
                  </c:pt>
                  <c:pt idx="1">
                    <c:v>2.1610121326591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E$11:$F$11</c:f>
              <c:numCache>
                <c:formatCode>General</c:formatCode>
                <c:ptCount val="2"/>
                <c:pt idx="0">
                  <c:v>9.0225000000000009</c:v>
                </c:pt>
                <c:pt idx="1">
                  <c:v>11.71374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268800"/>
        <c:axId val="110270336"/>
      </c:barChart>
      <c:catAx>
        <c:axId val="110268800"/>
        <c:scaling>
          <c:orientation val="minMax"/>
        </c:scaling>
        <c:delete val="0"/>
        <c:axPos val="b"/>
        <c:majorTickMark val="out"/>
        <c:minorTickMark val="none"/>
        <c:tickLblPos val="nextTo"/>
        <c:crossAx val="110270336"/>
        <c:crosses val="autoZero"/>
        <c:auto val="1"/>
        <c:lblAlgn val="ctr"/>
        <c:lblOffset val="100"/>
        <c:noMultiLvlLbl val="0"/>
      </c:catAx>
      <c:valAx>
        <c:axId val="110270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102688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M$14:$N$14</c:f>
                <c:numCache>
                  <c:formatCode>General</c:formatCode>
                  <c:ptCount val="2"/>
                  <c:pt idx="0">
                    <c:v>1.52367539765632</c:v>
                  </c:pt>
                  <c:pt idx="1">
                    <c:v>6.67402821806341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M$13:$N$13</c:f>
              <c:numCache>
                <c:formatCode>General</c:formatCode>
                <c:ptCount val="2"/>
                <c:pt idx="0">
                  <c:v>8.7052422006887937</c:v>
                </c:pt>
                <c:pt idx="1">
                  <c:v>26.5459995226959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283008"/>
        <c:axId val="110292992"/>
      </c:barChart>
      <c:catAx>
        <c:axId val="110283008"/>
        <c:scaling>
          <c:orientation val="minMax"/>
        </c:scaling>
        <c:delete val="0"/>
        <c:axPos val="b"/>
        <c:majorTickMark val="out"/>
        <c:minorTickMark val="none"/>
        <c:tickLblPos val="nextTo"/>
        <c:crossAx val="110292992"/>
        <c:crosses val="autoZero"/>
        <c:auto val="1"/>
        <c:lblAlgn val="ctr"/>
        <c:lblOffset val="100"/>
        <c:noMultiLvlLbl val="0"/>
      </c:catAx>
      <c:valAx>
        <c:axId val="110292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1028300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463</cdr:x>
      <cdr:y>0.84507</cdr:y>
    </cdr:from>
    <cdr:to>
      <cdr:x>0.97817</cdr:x>
      <cdr:y>1</cdr:y>
    </cdr:to>
    <cdr:sp macro="" textlink="">
      <cdr:nvSpPr>
        <cdr:cNvPr id="2" name="正方形/長方形 1"/>
        <cdr:cNvSpPr/>
      </cdr:nvSpPr>
      <cdr:spPr>
        <a:xfrm xmlns:a="http://schemas.openxmlformats.org/drawingml/2006/main">
          <a:off x="344780" y="1273370"/>
          <a:ext cx="2160240" cy="233451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ja-JP" sz="16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12959</cdr:x>
      <cdr:y>0.72242</cdr:y>
    </cdr:from>
    <cdr:to>
      <cdr:x>0.97313</cdr:x>
      <cdr:y>0.87735</cdr:y>
    </cdr:to>
    <cdr:sp macro="" textlink="">
      <cdr:nvSpPr>
        <cdr:cNvPr id="3" name="正方形/長方形 2"/>
        <cdr:cNvSpPr/>
      </cdr:nvSpPr>
      <cdr:spPr>
        <a:xfrm xmlns:a="http://schemas.openxmlformats.org/drawingml/2006/main">
          <a:off x="274923" y="790917"/>
          <a:ext cx="1789614" cy="169619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200" dirty="0" smtClean="0">
              <a:solidFill>
                <a:schemeClr val="tx1"/>
              </a:solidFill>
            </a:rPr>
            <a:t>      control        PTX3(-)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BB174A-E7B4-40C5-8875-5393B5F8AA6C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CA97C7-1624-44F8-B0DD-D4D0290C31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070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61AA86-83A8-435D-A9A0-7CA0699EE9F0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3927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8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875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3099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5" y="396703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1331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7886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3105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4740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8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7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8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68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5078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641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94410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5130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73535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A61DC-EB76-44ED-B794-F719A8CA424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9/1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29EBB-E2A1-4EB8-8C90-47614306014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9162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4624" y="-179365"/>
            <a:ext cx="6974532" cy="739877"/>
          </a:xfrm>
        </p:spPr>
        <p:txBody>
          <a:bodyPr>
            <a:noAutofit/>
          </a:bodyPr>
          <a:lstStyle/>
          <a:p>
            <a:pPr algn="l"/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1966579"/>
              </p:ext>
            </p:extLst>
          </p:nvPr>
        </p:nvGraphicFramePr>
        <p:xfrm>
          <a:off x="695538" y="549005"/>
          <a:ext cx="4965710" cy="31024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 rot="16200000">
            <a:off x="-1055766" y="1997556"/>
            <a:ext cx="28162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>
                <a:solidFill>
                  <a:prstClr val="black"/>
                </a:solidFill>
              </a:rPr>
              <a:t>PTX3 concentration </a:t>
            </a:r>
            <a:r>
              <a:rPr lang="en-US" altLang="ja-JP">
                <a:solidFill>
                  <a:prstClr val="black"/>
                </a:solidFill>
              </a:rPr>
              <a:t>(</a:t>
            </a:r>
            <a:r>
              <a:rPr lang="en-US" altLang="en-US">
                <a:solidFill>
                  <a:prstClr val="black"/>
                </a:solidFill>
              </a:rPr>
              <a:t>ng/m</a:t>
            </a:r>
            <a:r>
              <a:rPr lang="en-US" altLang="ja-JP">
                <a:solidFill>
                  <a:prstClr val="black"/>
                </a:solidFill>
              </a:rPr>
              <a:t>L)</a:t>
            </a:r>
            <a:endParaRPr lang="en-US" altLang="en-US" dirty="0">
              <a:solidFill>
                <a:prstClr val="black"/>
              </a:solidFill>
            </a:endParaRPr>
          </a:p>
          <a:p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9209" y="549005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1.</a:t>
            </a:r>
          </a:p>
        </p:txBody>
      </p:sp>
    </p:spTree>
    <p:extLst>
      <p:ext uri="{BB962C8B-B14F-4D97-AF65-F5344CB8AC3E}">
        <p14:creationId xmlns:p14="http://schemas.microsoft.com/office/powerpoint/2010/main" val="1679632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 rot="16200000">
            <a:off x="3446769" y="8617179"/>
            <a:ext cx="149592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HLA-DR </a:t>
            </a:r>
          </a:p>
          <a:p>
            <a:r>
              <a:rPr lang="en-US" altLang="ja-JP" sz="105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itive cells (%)</a:t>
            </a:r>
            <a:endParaRPr lang="ja-JP" altLang="en-US" sz="105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5090172"/>
              </p:ext>
            </p:extLst>
          </p:nvPr>
        </p:nvGraphicFramePr>
        <p:xfrm>
          <a:off x="4331084" y="8346573"/>
          <a:ext cx="2121552" cy="13568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5804714" y="8154170"/>
            <a:ext cx="249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線コネクタ 22"/>
          <p:cNvCxnSpPr/>
          <p:nvPr/>
        </p:nvCxnSpPr>
        <p:spPr>
          <a:xfrm>
            <a:off x="3758781" y="6188741"/>
            <a:ext cx="142422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5723904" y="6163468"/>
            <a:ext cx="142422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/>
          <p:cNvSpPr txBox="1"/>
          <p:nvPr/>
        </p:nvSpPr>
        <p:spPr>
          <a:xfrm>
            <a:off x="2201786" y="7808721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TX3(-)</a:t>
            </a:r>
          </a:p>
        </p:txBody>
      </p:sp>
      <p:grpSp>
        <p:nvGrpSpPr>
          <p:cNvPr id="29" name="グループ化 28"/>
          <p:cNvGrpSpPr>
            <a:grpSpLocks noChangeAspect="1"/>
          </p:cNvGrpSpPr>
          <p:nvPr/>
        </p:nvGrpSpPr>
        <p:grpSpPr>
          <a:xfrm>
            <a:off x="2168844" y="4149828"/>
            <a:ext cx="4704552" cy="3543072"/>
            <a:chOff x="2885031" y="3385262"/>
            <a:chExt cx="1901536" cy="1431745"/>
          </a:xfrm>
        </p:grpSpPr>
        <p:pic>
          <p:nvPicPr>
            <p:cNvPr id="30" name="Picture 3" descr="C:\Users\fujiuser1\Documents\PTX3関連\Pros one\figures\HLADR PTX3KO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85031" y="3385262"/>
              <a:ext cx="1901536" cy="14317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1" name="直線コネクタ 30"/>
            <p:cNvCxnSpPr/>
            <p:nvPr/>
          </p:nvCxnSpPr>
          <p:spPr>
            <a:xfrm>
              <a:off x="3735474" y="4117155"/>
              <a:ext cx="142422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グループ化 31"/>
          <p:cNvGrpSpPr>
            <a:grpSpLocks noChangeAspect="1"/>
          </p:cNvGrpSpPr>
          <p:nvPr/>
        </p:nvGrpSpPr>
        <p:grpSpPr>
          <a:xfrm>
            <a:off x="2182906" y="360394"/>
            <a:ext cx="4557695" cy="3432468"/>
            <a:chOff x="4872028" y="3423884"/>
            <a:chExt cx="1859025" cy="1399736"/>
          </a:xfrm>
        </p:grpSpPr>
        <p:pic>
          <p:nvPicPr>
            <p:cNvPr id="33" name="Picture 2" descr="C:\Users\fujiuser1\Documents\PTX3関連\Pros one\figures\HLADR PTX3 exist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72028" y="3423884"/>
              <a:ext cx="1859025" cy="13997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4" name="直線コネクタ 33"/>
            <p:cNvCxnSpPr/>
            <p:nvPr/>
          </p:nvCxnSpPr>
          <p:spPr>
            <a:xfrm>
              <a:off x="5659119" y="4102390"/>
              <a:ext cx="142422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テキスト ボックス 34"/>
          <p:cNvSpPr txBox="1"/>
          <p:nvPr/>
        </p:nvSpPr>
        <p:spPr>
          <a:xfrm>
            <a:off x="2103203" y="3806537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17716" y="-24844"/>
            <a:ext cx="374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 solution images of Figure 3 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線コネクタ 2"/>
          <p:cNvCxnSpPr/>
          <p:nvPr/>
        </p:nvCxnSpPr>
        <p:spPr>
          <a:xfrm>
            <a:off x="117716" y="2024244"/>
            <a:ext cx="1942452" cy="0"/>
          </a:xfrm>
          <a:prstGeom prst="line">
            <a:avLst/>
          </a:prstGeom>
          <a:ln w="508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 flipV="1">
            <a:off x="1052736" y="1424608"/>
            <a:ext cx="0" cy="1184084"/>
          </a:xfrm>
          <a:prstGeom prst="line">
            <a:avLst/>
          </a:prstGeom>
          <a:ln w="508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1240466" y="1560886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-D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0" y="2216376"/>
            <a:ext cx="9989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echst33342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137327" y="2237971"/>
            <a:ext cx="9925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contrast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17716" y="1499331"/>
            <a:ext cx="783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ge</a:t>
            </a:r>
          </a:p>
        </p:txBody>
      </p:sp>
    </p:spTree>
    <p:extLst>
      <p:ext uri="{BB962C8B-B14F-4D97-AF65-F5344CB8AC3E}">
        <p14:creationId xmlns:p14="http://schemas.microsoft.com/office/powerpoint/2010/main" val="725622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 rot="16200000">
            <a:off x="4014767" y="8840653"/>
            <a:ext cx="130837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CD86 </a:t>
            </a:r>
          </a:p>
          <a:p>
            <a:r>
              <a:rPr lang="en-US" altLang="ja-JP" sz="105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itive cells (%)</a:t>
            </a:r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0192249"/>
              </p:ext>
            </p:extLst>
          </p:nvPr>
        </p:nvGraphicFramePr>
        <p:xfrm>
          <a:off x="4822845" y="8337376"/>
          <a:ext cx="1872205" cy="1466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4945702" y="9553527"/>
            <a:ext cx="1939532" cy="4400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    PTX3(-)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040952" y="84137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726594" y="4088904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control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775719" y="8338836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TX3(-)</a:t>
            </a:r>
          </a:p>
        </p:txBody>
      </p:sp>
      <p:pic>
        <p:nvPicPr>
          <p:cNvPr id="13" name="Picture 4" descr="C:\Users\fujiuser1\Documents\PTX3関連\Pros one\figures\CD86 PTX3KO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2663" y="4427993"/>
            <a:ext cx="5095337" cy="3837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5" descr="C:\Users\fujiuser1\Documents\PTX3関連\Pros one\figures\CD86 PTX3 exists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9780" y="322894"/>
            <a:ext cx="5036228" cy="37928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テキスト ボックス 14"/>
          <p:cNvSpPr txBox="1"/>
          <p:nvPr/>
        </p:nvSpPr>
        <p:spPr>
          <a:xfrm>
            <a:off x="545554" y="19265"/>
            <a:ext cx="723706" cy="380587"/>
          </a:xfrm>
          <a:prstGeom prst="rect">
            <a:avLst/>
          </a:prstGeom>
          <a:noFill/>
        </p:spPr>
        <p:txBody>
          <a:bodyPr wrap="square" lIns="102587" tIns="51293" rIns="102587" bIns="51293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Ｃ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線コネクタ 16"/>
          <p:cNvCxnSpPr/>
          <p:nvPr/>
        </p:nvCxnSpPr>
        <p:spPr>
          <a:xfrm>
            <a:off x="3860949" y="2008037"/>
            <a:ext cx="34917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3932940" y="6113136"/>
            <a:ext cx="34917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0" y="16024"/>
            <a:ext cx="374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 solution images of Figure 3 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線コネクタ 19"/>
          <p:cNvCxnSpPr/>
          <p:nvPr/>
        </p:nvCxnSpPr>
        <p:spPr>
          <a:xfrm flipV="1">
            <a:off x="117716" y="2008037"/>
            <a:ext cx="1515900" cy="16207"/>
          </a:xfrm>
          <a:prstGeom prst="line">
            <a:avLst/>
          </a:prstGeom>
          <a:ln w="508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 flipV="1">
            <a:off x="998991" y="1441211"/>
            <a:ext cx="0" cy="1184084"/>
          </a:xfrm>
          <a:prstGeom prst="line">
            <a:avLst/>
          </a:prstGeom>
          <a:ln w="508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1136433" y="1560886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86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0" y="2216376"/>
            <a:ext cx="9989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echst33342</a:t>
            </a: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052736" y="2145849"/>
            <a:ext cx="62869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ast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17716" y="1499331"/>
            <a:ext cx="783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ge</a:t>
            </a:r>
          </a:p>
        </p:txBody>
      </p:sp>
    </p:spTree>
    <p:extLst>
      <p:ext uri="{BB962C8B-B14F-4D97-AF65-F5344CB8AC3E}">
        <p14:creationId xmlns:p14="http://schemas.microsoft.com/office/powerpoint/2010/main" val="190890403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74</Words>
  <Application>Microsoft Office PowerPoint</Application>
  <PresentationFormat>A4 210 x 297 mm</PresentationFormat>
  <Paragraphs>29</Paragraphs>
  <Slides>3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1_Office ​​テーマ</vt:lpstr>
      <vt:lpstr>Supplementary data 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</dc:title>
  <dc:creator>FJ-USER</dc:creator>
  <cp:lastModifiedBy>FJ-USER</cp:lastModifiedBy>
  <cp:revision>2</cp:revision>
  <dcterms:created xsi:type="dcterms:W3CDTF">2015-09-15T01:46:20Z</dcterms:created>
  <dcterms:modified xsi:type="dcterms:W3CDTF">2015-09-15T02:16:53Z</dcterms:modified>
</cp:coreProperties>
</file>